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272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6367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1062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2369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593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4604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0179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876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8728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53800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9180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4434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4EBE0-09A2-40A2-95CA-43326462AE7A}" type="datetimeFigureOut">
              <a:rPr lang="zh-CN" altLang="en-US" smtClean="0"/>
              <a:t>2024/01/2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494C2C-D686-440A-B3E1-4391DE2059E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8613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979DAF-4ADF-4813-99C8-99388F60F2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181EF34-9ED5-404C-A8F5-1142D20328CC}"/>
              </a:ext>
            </a:extLst>
          </p:cNvPr>
          <p:cNvSpPr txBox="1"/>
          <p:nvPr/>
        </p:nvSpPr>
        <p:spPr>
          <a:xfrm>
            <a:off x="2303930" y="6507487"/>
            <a:ext cx="22501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oradic miscarriage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D41BE34C-BB4C-4FCF-965B-F09D318E51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32524" cy="61228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118692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64DAA94-89EF-4E98-9711-0F554593BC9A}"/>
              </a:ext>
            </a:extLst>
          </p:cNvPr>
          <p:cNvSpPr txBox="1"/>
          <p:nvPr/>
        </p:nvSpPr>
        <p:spPr>
          <a:xfrm>
            <a:off x="2390257" y="7273716"/>
            <a:ext cx="207748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lacental abruptio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3D3D1C4-2384-43DE-A2DD-4D97F95211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145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940811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AFBCCE5-00AF-4185-BD15-645D6B4E0350}"/>
              </a:ext>
            </a:extLst>
          </p:cNvPr>
          <p:cNvSpPr txBox="1"/>
          <p:nvPr/>
        </p:nvSpPr>
        <p:spPr>
          <a:xfrm>
            <a:off x="1679151" y="6959951"/>
            <a:ext cx="34996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remature rupture of membranes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995A8C9-9EA2-4D6E-9AF2-3753CBB53B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-16313"/>
            <a:ext cx="6860730" cy="61481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168142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793B600-D6C1-41FD-9AC2-1FF35AFBC65F}"/>
              </a:ext>
            </a:extLst>
          </p:cNvPr>
          <p:cNvSpPr txBox="1"/>
          <p:nvPr/>
        </p:nvSpPr>
        <p:spPr>
          <a:xfrm>
            <a:off x="2217032" y="7399222"/>
            <a:ext cx="24239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ostpartum hemorrhage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475E130-D065-4C08-9184-A6DEEEB5EB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21" y="45404"/>
            <a:ext cx="6841879" cy="6131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319135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EF19E85A-F752-42DA-B7A8-6BA78873BCD1}"/>
              </a:ext>
            </a:extLst>
          </p:cNvPr>
          <p:cNvSpPr txBox="1"/>
          <p:nvPr/>
        </p:nvSpPr>
        <p:spPr>
          <a:xfrm>
            <a:off x="2305078" y="6820799"/>
            <a:ext cx="22478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ostpartum depressio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AEB7EE7-A141-46DC-80FF-CC0F818EB1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145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777214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4BFC2B0-6D07-4446-B344-468F80C10A8E}"/>
              </a:ext>
            </a:extLst>
          </p:cNvPr>
          <p:cNvSpPr txBox="1"/>
          <p:nvPr/>
        </p:nvSpPr>
        <p:spPr>
          <a:xfrm>
            <a:off x="2463410" y="7331788"/>
            <a:ext cx="19311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oor fetal growth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CAC2FD7F-2F95-485B-A43C-2DDF3099BF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145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9197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260E571-645A-403E-B056-35AFC0DA0F50}"/>
              </a:ext>
            </a:extLst>
          </p:cNvPr>
          <p:cNvSpPr txBox="1"/>
          <p:nvPr/>
        </p:nvSpPr>
        <p:spPr>
          <a:xfrm>
            <a:off x="2324954" y="6606566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gestational </a:t>
            </a:r>
            <a:r>
              <a:rPr lang="en-US" altLang="zh-CN"/>
              <a:t>diabetes mellitus</a:t>
            </a:r>
            <a:endParaRPr lang="en-US" altLang="zh-CN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8F26C86-482D-4BB0-8274-82B5D1FA7A4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18734"/>
            <a:ext cx="6826620" cy="61176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5244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93F4C7F-02C3-43F1-9A34-8B0DDF5A5589}"/>
              </a:ext>
            </a:extLst>
          </p:cNvPr>
          <p:cNvSpPr txBox="1"/>
          <p:nvPr/>
        </p:nvSpPr>
        <p:spPr>
          <a:xfrm>
            <a:off x="1610591" y="7547860"/>
            <a:ext cx="363681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hypertensive disorder of pregnancy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59AA617-0A9F-4D48-AA18-0E6E2A16CF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0" y="10141"/>
            <a:ext cx="6861217" cy="6148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40305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8A989EF7-D847-4FBE-B3E0-64951F580A6B}"/>
              </a:ext>
            </a:extLst>
          </p:cNvPr>
          <p:cNvSpPr txBox="1"/>
          <p:nvPr/>
        </p:nvSpPr>
        <p:spPr>
          <a:xfrm>
            <a:off x="2168393" y="7754049"/>
            <a:ext cx="25212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gestational hypertensio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C53D11D-6A4D-4153-9899-B1E3761829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80" y="0"/>
            <a:ext cx="6822520" cy="61139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784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09FD797-1FBD-43B3-BAB8-B23EF37EB270}"/>
              </a:ext>
            </a:extLst>
          </p:cNvPr>
          <p:cNvSpPr txBox="1"/>
          <p:nvPr/>
        </p:nvSpPr>
        <p:spPr>
          <a:xfrm>
            <a:off x="2033766" y="6960541"/>
            <a:ext cx="27904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re-eclampsia or eclampsia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D296691-FE20-4CE7-8B44-CFC25FC7F7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" y="-4832"/>
            <a:ext cx="6858001" cy="6145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281020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FD69CE1-DB6E-4ABE-866D-56BB3ADE0060}"/>
              </a:ext>
            </a:extLst>
          </p:cNvPr>
          <p:cNvSpPr txBox="1"/>
          <p:nvPr/>
        </p:nvSpPr>
        <p:spPr>
          <a:xfrm>
            <a:off x="2525330" y="7202588"/>
            <a:ext cx="180734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olyhydramnios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8ED4367-0254-481F-9BAC-DA1ECCFD04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2533" y="-2222"/>
            <a:ext cx="6880533" cy="61659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101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E81FBF2-FA69-4715-9047-C331EEB3B637}"/>
              </a:ext>
            </a:extLst>
          </p:cNvPr>
          <p:cNvSpPr txBox="1"/>
          <p:nvPr/>
        </p:nvSpPr>
        <p:spPr>
          <a:xfrm>
            <a:off x="3021901" y="6479641"/>
            <a:ext cx="81419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ICP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CF85253-62C8-40EF-B2D7-29DE6DD706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145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84538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2F130F9-4003-4A64-822B-00FB92163972}"/>
              </a:ext>
            </a:extLst>
          </p:cNvPr>
          <p:cNvSpPr txBox="1"/>
          <p:nvPr/>
        </p:nvSpPr>
        <p:spPr>
          <a:xfrm>
            <a:off x="2513015" y="6613732"/>
            <a:ext cx="18319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lacenta disorder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466D314-E7F7-4D67-AA3D-A9846C1676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28385"/>
            <a:ext cx="6858000" cy="61457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97305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D917406-F1C1-4FA6-A772-3C7FFAEC0871}"/>
              </a:ext>
            </a:extLst>
          </p:cNvPr>
          <p:cNvSpPr txBox="1"/>
          <p:nvPr/>
        </p:nvSpPr>
        <p:spPr>
          <a:xfrm>
            <a:off x="2595170" y="7228893"/>
            <a:ext cx="16676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placenta previa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25624B00-C689-46F3-93D1-F99598D0CA6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4194"/>
            <a:ext cx="6856700" cy="61445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8796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</TotalTime>
  <Words>33</Words>
  <Application>Microsoft Office PowerPoint</Application>
  <PresentationFormat>A4 纸张(210x297 毫米)</PresentationFormat>
  <Paragraphs>14</Paragraphs>
  <Slides>1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9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* alin</dc:creator>
  <cp:lastModifiedBy>alin *</cp:lastModifiedBy>
  <cp:revision>9</cp:revision>
  <dcterms:created xsi:type="dcterms:W3CDTF">2023-09-07T08:52:57Z</dcterms:created>
  <dcterms:modified xsi:type="dcterms:W3CDTF">2024-01-23T08:36:58Z</dcterms:modified>
</cp:coreProperties>
</file>